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1968" y="2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5B8DD-937F-4EAC-A445-2CC278EE6D1F}" type="datetimeFigureOut">
              <a:rPr lang="en-US" smtClean="0"/>
              <a:t>11/1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A0438-FE21-48FF-9713-EC1D3DB3A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16155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5B8DD-937F-4EAC-A445-2CC278EE6D1F}" type="datetimeFigureOut">
              <a:rPr lang="en-US" smtClean="0"/>
              <a:t>11/1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A0438-FE21-48FF-9713-EC1D3DB3A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701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5B8DD-937F-4EAC-A445-2CC278EE6D1F}" type="datetimeFigureOut">
              <a:rPr lang="en-US" smtClean="0"/>
              <a:t>11/1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A0438-FE21-48FF-9713-EC1D3DB3A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7920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5B8DD-937F-4EAC-A445-2CC278EE6D1F}" type="datetimeFigureOut">
              <a:rPr lang="en-US" smtClean="0"/>
              <a:t>11/1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A0438-FE21-48FF-9713-EC1D3DB3A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553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5B8DD-937F-4EAC-A445-2CC278EE6D1F}" type="datetimeFigureOut">
              <a:rPr lang="en-US" smtClean="0"/>
              <a:t>11/1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A0438-FE21-48FF-9713-EC1D3DB3A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190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5B8DD-937F-4EAC-A445-2CC278EE6D1F}" type="datetimeFigureOut">
              <a:rPr lang="en-US" smtClean="0"/>
              <a:t>11/1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A0438-FE21-48FF-9713-EC1D3DB3A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6565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5B8DD-937F-4EAC-A445-2CC278EE6D1F}" type="datetimeFigureOut">
              <a:rPr lang="en-US" smtClean="0"/>
              <a:t>11/1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A0438-FE21-48FF-9713-EC1D3DB3A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955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5B8DD-937F-4EAC-A445-2CC278EE6D1F}" type="datetimeFigureOut">
              <a:rPr lang="en-US" smtClean="0"/>
              <a:t>11/1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A0438-FE21-48FF-9713-EC1D3DB3A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4507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5B8DD-937F-4EAC-A445-2CC278EE6D1F}" type="datetimeFigureOut">
              <a:rPr lang="en-US" smtClean="0"/>
              <a:t>11/1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A0438-FE21-48FF-9713-EC1D3DB3A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48247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5B8DD-937F-4EAC-A445-2CC278EE6D1F}" type="datetimeFigureOut">
              <a:rPr lang="en-US" smtClean="0"/>
              <a:t>11/1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A0438-FE21-48FF-9713-EC1D3DB3A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5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5B8DD-937F-4EAC-A445-2CC278EE6D1F}" type="datetimeFigureOut">
              <a:rPr lang="en-US" smtClean="0"/>
              <a:t>11/1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A0438-FE21-48FF-9713-EC1D3DB3A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6376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65B8DD-937F-4EAC-A445-2CC278EE6D1F}" type="datetimeFigureOut">
              <a:rPr lang="en-US" smtClean="0"/>
              <a:t>11/1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A0438-FE21-48FF-9713-EC1D3DB3A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18732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4801" y="5410200"/>
            <a:ext cx="838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ch tissue is represented by a different color.  The order within a tissue-sex is 2 weeks of age, 6 weeks of age, 21 weeks of age, and 104 weeks of age, with 4 biological replicates at each age.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r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adrenal gland;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r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brain;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r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heart;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n: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idney;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ng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lung;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vr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liver;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s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strocnemius muscle;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l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spleen;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m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thymus;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s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testes;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tr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uterus; M: male; F: female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-12192" y="152400"/>
            <a:ext cx="9156192" cy="4816318"/>
            <a:chOff x="-12192" y="152400"/>
            <a:chExt cx="9156192" cy="4816318"/>
          </a:xfrm>
        </p:grpSpPr>
        <p:pic>
          <p:nvPicPr>
            <p:cNvPr id="5122" name="Picture 2" descr="express_prof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12192" y="152400"/>
              <a:ext cx="4727448" cy="221599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161"/>
            <a:stretch/>
          </p:blipFill>
          <p:spPr bwMode="auto">
            <a:xfrm>
              <a:off x="4568952" y="153829"/>
              <a:ext cx="4575048" cy="22145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8" name="Straight Arrow Connector 7"/>
            <p:cNvCxnSpPr/>
            <p:nvPr/>
          </p:nvCxnSpPr>
          <p:spPr>
            <a:xfrm flipH="1">
              <a:off x="2362200" y="1111612"/>
              <a:ext cx="152400" cy="22860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Arrow Connector 10"/>
            <p:cNvCxnSpPr/>
            <p:nvPr/>
          </p:nvCxnSpPr>
          <p:spPr>
            <a:xfrm flipH="1">
              <a:off x="8097984" y="198120"/>
              <a:ext cx="152400" cy="22860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4" name="Picture 2" descr="express_prof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12192" y="2752727"/>
              <a:ext cx="4727448" cy="221599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12" name="Straight Arrow Connector 11"/>
            <p:cNvCxnSpPr/>
            <p:nvPr/>
          </p:nvCxnSpPr>
          <p:spPr>
            <a:xfrm flipH="1">
              <a:off x="876300" y="2793553"/>
              <a:ext cx="152400" cy="22860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7" name="Picture 2" descr="express_prof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224"/>
            <a:stretch/>
          </p:blipFill>
          <p:spPr bwMode="auto">
            <a:xfrm>
              <a:off x="4568952" y="2752726"/>
              <a:ext cx="4575048" cy="221599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13" name="Straight Arrow Connector 12"/>
            <p:cNvCxnSpPr/>
            <p:nvPr/>
          </p:nvCxnSpPr>
          <p:spPr>
            <a:xfrm flipH="1">
              <a:off x="6941823" y="3595732"/>
              <a:ext cx="152400" cy="22860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8228241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98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S FD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uscoe, James</dc:creator>
  <cp:lastModifiedBy>Vijay, Vikrant</cp:lastModifiedBy>
  <cp:revision>10</cp:revision>
  <dcterms:created xsi:type="dcterms:W3CDTF">2016-11-15T16:17:47Z</dcterms:created>
  <dcterms:modified xsi:type="dcterms:W3CDTF">2016-11-17T20:21:29Z</dcterms:modified>
</cp:coreProperties>
</file>